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6DB26A-6FFD-4C3E-A3DC-D8144A91EABF}" v="1" dt="2026-04-25T11:38:09.09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25" autoAdjust="0"/>
    <p:restoredTop sz="94660"/>
  </p:normalViewPr>
  <p:slideViewPr>
    <p:cSldViewPr snapToGrid="0">
      <p:cViewPr varScale="1">
        <p:scale>
          <a:sx n="82" d="100"/>
          <a:sy n="82" d="100"/>
        </p:scale>
        <p:origin x="40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nne, Isabelle" userId="68246d2c-cea7-41e5-ae68-061af3e0a041" providerId="ADAL" clId="{E5DDC2F5-41B0-4C65-A84B-E802C2363F07}"/>
    <pc:docChg chg="custSel modSld">
      <pc:chgData name="Panne, Isabelle" userId="68246d2c-cea7-41e5-ae68-061af3e0a041" providerId="ADAL" clId="{E5DDC2F5-41B0-4C65-A84B-E802C2363F07}" dt="2026-04-20T12:01:56.938" v="748" actId="1037"/>
      <pc:docMkLst>
        <pc:docMk/>
      </pc:docMkLst>
      <pc:sldChg chg="addSp delSp modSp mod">
        <pc:chgData name="Panne, Isabelle" userId="68246d2c-cea7-41e5-ae68-061af3e0a041" providerId="ADAL" clId="{E5DDC2F5-41B0-4C65-A84B-E802C2363F07}" dt="2026-04-20T12:01:56.938" v="748" actId="1037"/>
        <pc:sldMkLst>
          <pc:docMk/>
          <pc:sldMk cId="1907904869" sldId="256"/>
        </pc:sldMkLst>
        <pc:spChg chg="add mod">
          <ac:chgData name="Panne, Isabelle" userId="68246d2c-cea7-41e5-ae68-061af3e0a041" providerId="ADAL" clId="{E5DDC2F5-41B0-4C65-A84B-E802C2363F07}" dt="2026-04-14T04:31:18.615" v="700" actId="20577"/>
          <ac:spMkLst>
            <pc:docMk/>
            <pc:sldMk cId="1907904869" sldId="256"/>
            <ac:spMk id="11" creationId="{2C759F45-CC45-E3B0-FBDF-19ABE8636DB5}"/>
          </ac:spMkLst>
        </pc:spChg>
        <pc:spChg chg="add mod">
          <ac:chgData name="Panne, Isabelle" userId="68246d2c-cea7-41e5-ae68-061af3e0a041" providerId="ADAL" clId="{E5DDC2F5-41B0-4C65-A84B-E802C2363F07}" dt="2026-04-14T04:20:01.971" v="507" actId="1035"/>
          <ac:spMkLst>
            <pc:docMk/>
            <pc:sldMk cId="1907904869" sldId="256"/>
            <ac:spMk id="15" creationId="{B8627E23-E090-2D48-4C61-2A4994D37522}"/>
          </ac:spMkLst>
        </pc:spChg>
        <pc:spChg chg="add mod">
          <ac:chgData name="Panne, Isabelle" userId="68246d2c-cea7-41e5-ae68-061af3e0a041" providerId="ADAL" clId="{E5DDC2F5-41B0-4C65-A84B-E802C2363F07}" dt="2026-04-14T04:22:11.252" v="516" actId="207"/>
          <ac:spMkLst>
            <pc:docMk/>
            <pc:sldMk cId="1907904869" sldId="256"/>
            <ac:spMk id="18" creationId="{245DBFCD-75B8-8FE6-7A09-EE7A704CE56C}"/>
          </ac:spMkLst>
        </pc:spChg>
        <pc:spChg chg="add mod">
          <ac:chgData name="Panne, Isabelle" userId="68246d2c-cea7-41e5-ae68-061af3e0a041" providerId="ADAL" clId="{E5DDC2F5-41B0-4C65-A84B-E802C2363F07}" dt="2026-04-14T04:27:10.396" v="595" actId="1076"/>
          <ac:spMkLst>
            <pc:docMk/>
            <pc:sldMk cId="1907904869" sldId="256"/>
            <ac:spMk id="23" creationId="{0E57D767-89E1-9C81-9D02-16D5E3DA9C14}"/>
          </ac:spMkLst>
        </pc:spChg>
        <pc:spChg chg="add mod">
          <ac:chgData name="Panne, Isabelle" userId="68246d2c-cea7-41e5-ae68-061af3e0a041" providerId="ADAL" clId="{E5DDC2F5-41B0-4C65-A84B-E802C2363F07}" dt="2026-04-14T04:28:33.674" v="641" actId="20577"/>
          <ac:spMkLst>
            <pc:docMk/>
            <pc:sldMk cId="1907904869" sldId="256"/>
            <ac:spMk id="24" creationId="{670042BD-3545-4D98-79EE-289EC6F40473}"/>
          </ac:spMkLst>
        </pc:spChg>
        <pc:spChg chg="add mod">
          <ac:chgData name="Panne, Isabelle" userId="68246d2c-cea7-41e5-ae68-061af3e0a041" providerId="ADAL" clId="{E5DDC2F5-41B0-4C65-A84B-E802C2363F07}" dt="2026-04-14T04:23:16.286" v="534" actId="1076"/>
          <ac:spMkLst>
            <pc:docMk/>
            <pc:sldMk cId="1907904869" sldId="256"/>
            <ac:spMk id="25" creationId="{FEB0B325-0613-2994-0DE8-BFF462A8CABA}"/>
          </ac:spMkLst>
        </pc:spChg>
        <pc:spChg chg="add mod">
          <ac:chgData name="Panne, Isabelle" userId="68246d2c-cea7-41e5-ae68-061af3e0a041" providerId="ADAL" clId="{E5DDC2F5-41B0-4C65-A84B-E802C2363F07}" dt="2026-04-14T04:24:26.358" v="541" actId="1076"/>
          <ac:spMkLst>
            <pc:docMk/>
            <pc:sldMk cId="1907904869" sldId="256"/>
            <ac:spMk id="30" creationId="{0622E935-0D25-3E4D-8A46-AC8F2ED22147}"/>
          </ac:spMkLst>
        </pc:spChg>
        <pc:spChg chg="add mod">
          <ac:chgData name="Panne, Isabelle" userId="68246d2c-cea7-41e5-ae68-061af3e0a041" providerId="ADAL" clId="{E5DDC2F5-41B0-4C65-A84B-E802C2363F07}" dt="2026-04-14T04:25:02.411" v="547" actId="207"/>
          <ac:spMkLst>
            <pc:docMk/>
            <pc:sldMk cId="1907904869" sldId="256"/>
            <ac:spMk id="36" creationId="{20C9EF9D-A38E-ABDF-1773-B004DC959EC8}"/>
          </ac:spMkLst>
        </pc:spChg>
        <pc:graphicFrameChg chg="mod">
          <ac:chgData name="Panne, Isabelle" userId="68246d2c-cea7-41e5-ae68-061af3e0a041" providerId="ADAL" clId="{E5DDC2F5-41B0-4C65-A84B-E802C2363F07}" dt="2026-04-14T04:19:31.139" v="474" actId="1076"/>
          <ac:graphicFrameMkLst>
            <pc:docMk/>
            <pc:sldMk cId="1907904869" sldId="256"/>
            <ac:graphicFrameMk id="4" creationId="{07AB0080-2014-A8C0-6C2C-255EDEE9D70D}"/>
          </ac:graphicFrameMkLst>
        </pc:graphicFrameChg>
        <pc:picChg chg="add mod modCrop">
          <ac:chgData name="Panne, Isabelle" userId="68246d2c-cea7-41e5-ae68-061af3e0a041" providerId="ADAL" clId="{E5DDC2F5-41B0-4C65-A84B-E802C2363F07}" dt="2026-04-20T12:01:56.938" v="748" actId="1037"/>
          <ac:picMkLst>
            <pc:docMk/>
            <pc:sldMk cId="1907904869" sldId="256"/>
            <ac:picMk id="8" creationId="{26687E33-857F-23F8-73A0-31CE16E83F3A}"/>
          </ac:picMkLst>
        </pc:picChg>
        <pc:picChg chg="add mod">
          <ac:chgData name="Panne, Isabelle" userId="68246d2c-cea7-41e5-ae68-061af3e0a041" providerId="ADAL" clId="{E5DDC2F5-41B0-4C65-A84B-E802C2363F07}" dt="2026-04-14T04:27:49.582" v="596" actId="1076"/>
          <ac:picMkLst>
            <pc:docMk/>
            <pc:sldMk cId="1907904869" sldId="256"/>
            <ac:picMk id="9" creationId="{EFBD28F9-A844-68BB-0AA0-8FC5EA060BA6}"/>
          </ac:picMkLst>
        </pc:picChg>
        <pc:picChg chg="add mod">
          <ac:chgData name="Panne, Isabelle" userId="68246d2c-cea7-41e5-ae68-061af3e0a041" providerId="ADAL" clId="{E5DDC2F5-41B0-4C65-A84B-E802C2363F07}" dt="2026-04-14T04:29:15.990" v="682" actId="1035"/>
          <ac:picMkLst>
            <pc:docMk/>
            <pc:sldMk cId="1907904869" sldId="256"/>
            <ac:picMk id="10" creationId="{8E69B8B7-4933-0B5F-A99B-54F2F7320042}"/>
          </ac:picMkLst>
        </pc:picChg>
        <pc:cxnChg chg="add mod">
          <ac:chgData name="Panne, Isabelle" userId="68246d2c-cea7-41e5-ae68-061af3e0a041" providerId="ADAL" clId="{E5DDC2F5-41B0-4C65-A84B-E802C2363F07}" dt="2026-04-14T04:20:25.168" v="511" actId="14100"/>
          <ac:cxnSpMkLst>
            <pc:docMk/>
            <pc:sldMk cId="1907904869" sldId="256"/>
            <ac:cxnSpMk id="17" creationId="{0D229F4F-7A98-7FD6-1BA1-B2C53F57C52A}"/>
          </ac:cxnSpMkLst>
        </pc:cxnChg>
        <pc:cxnChg chg="add mod">
          <ac:chgData name="Panne, Isabelle" userId="68246d2c-cea7-41e5-ae68-061af3e0a041" providerId="ADAL" clId="{E5DDC2F5-41B0-4C65-A84B-E802C2363F07}" dt="2026-04-20T11:55:10.969" v="734" actId="14100"/>
          <ac:cxnSpMkLst>
            <pc:docMk/>
            <pc:sldMk cId="1907904869" sldId="256"/>
            <ac:cxnSpMk id="20" creationId="{4EBADFA4-8123-CAF5-3973-85E5E18DD53B}"/>
          </ac:cxnSpMkLst>
        </pc:cxnChg>
        <pc:cxnChg chg="add mod">
          <ac:chgData name="Panne, Isabelle" userId="68246d2c-cea7-41e5-ae68-061af3e0a041" providerId="ADAL" clId="{E5DDC2F5-41B0-4C65-A84B-E802C2363F07}" dt="2026-04-14T04:24:34.745" v="542" actId="14100"/>
          <ac:cxnSpMkLst>
            <pc:docMk/>
            <pc:sldMk cId="1907904869" sldId="256"/>
            <ac:cxnSpMk id="32" creationId="{969D66A4-744C-ACD7-7BAB-4A866BA861B3}"/>
          </ac:cxnSpMkLst>
        </pc:cxnChg>
        <pc:cxnChg chg="add mod">
          <ac:chgData name="Panne, Isabelle" userId="68246d2c-cea7-41e5-ae68-061af3e0a041" providerId="ADAL" clId="{E5DDC2F5-41B0-4C65-A84B-E802C2363F07}" dt="2026-04-14T04:24:53.279" v="546" actId="1076"/>
          <ac:cxnSpMkLst>
            <pc:docMk/>
            <pc:sldMk cId="1907904869" sldId="256"/>
            <ac:cxnSpMk id="38" creationId="{E7941BA5-860D-2D02-09CA-0803DE9B0AF5}"/>
          </ac:cxnSpMkLst>
        </pc:cxnChg>
      </pc:sldChg>
    </pc:docChg>
  </pc:docChgLst>
  <pc:docChgLst>
    <pc:chgData name="Panne, Isabelle" userId="S::isabelle.panne@clarunis.ch::68246d2c-cea7-41e5-ae68-061af3e0a041" providerId="AD" clId="Web-{EDD730CB-6578-9DB4-6FB9-6EBC8F85AC0B}"/>
    <pc:docChg chg="modSld">
      <pc:chgData name="Panne, Isabelle" userId="S::isabelle.panne@clarunis.ch::68246d2c-cea7-41e5-ae68-061af3e0a041" providerId="AD" clId="Web-{EDD730CB-6578-9DB4-6FB9-6EBC8F85AC0B}" dt="2026-04-13T12:23:33.065" v="1"/>
      <pc:docMkLst>
        <pc:docMk/>
      </pc:docMkLst>
      <pc:sldChg chg="addSp delSp modSp">
        <pc:chgData name="Panne, Isabelle" userId="S::isabelle.panne@clarunis.ch::68246d2c-cea7-41e5-ae68-061af3e0a041" providerId="AD" clId="Web-{EDD730CB-6578-9DB4-6FB9-6EBC8F85AC0B}" dt="2026-04-13T12:23:33.065" v="1"/>
        <pc:sldMkLst>
          <pc:docMk/>
          <pc:sldMk cId="1907904869" sldId="256"/>
        </pc:sldMkLst>
      </pc:sldChg>
    </pc:docChg>
  </pc:docChgLst>
  <pc:docChgLst>
    <pc:chgData name="Panne, Isabelle" userId="68246d2c-cea7-41e5-ae68-061af3e0a041" providerId="ADAL" clId="{7F90142C-2691-4CAD-A9FA-FC7E7537B507}"/>
    <pc:docChg chg="modSld">
      <pc:chgData name="Panne, Isabelle" userId="68246d2c-cea7-41e5-ae68-061af3e0a041" providerId="ADAL" clId="{7F90142C-2691-4CAD-A9FA-FC7E7537B507}" dt="2026-04-15T20:40:18.485" v="5"/>
      <pc:docMkLst>
        <pc:docMk/>
      </pc:docMkLst>
      <pc:sldChg chg="addSp modSp">
        <pc:chgData name="Panne, Isabelle" userId="68246d2c-cea7-41e5-ae68-061af3e0a041" providerId="ADAL" clId="{7F90142C-2691-4CAD-A9FA-FC7E7537B507}" dt="2026-04-15T20:40:18.485" v="5"/>
        <pc:sldMkLst>
          <pc:docMk/>
          <pc:sldMk cId="1907904869" sldId="256"/>
        </pc:sldMkLst>
        <pc:spChg chg="add mod">
          <ac:chgData name="Panne, Isabelle" userId="68246d2c-cea7-41e5-ae68-061af3e0a041" providerId="ADAL" clId="{7F90142C-2691-4CAD-A9FA-FC7E7537B507}" dt="2026-04-15T20:40:18.485" v="5"/>
          <ac:spMkLst>
            <pc:docMk/>
            <pc:sldMk cId="1907904869" sldId="256"/>
            <ac:spMk id="21" creationId="{5CD3D1AF-C258-3EE0-ED06-64179425358F}"/>
          </ac:spMkLst>
        </pc:spChg>
        <pc:graphicFrameChg chg="mod">
          <ac:chgData name="Panne, Isabelle" userId="68246d2c-cea7-41e5-ae68-061af3e0a041" providerId="ADAL" clId="{7F90142C-2691-4CAD-A9FA-FC7E7537B507}" dt="2026-04-15T20:39:37.786" v="4"/>
          <ac:graphicFrameMkLst>
            <pc:docMk/>
            <pc:sldMk cId="1907904869" sldId="256"/>
            <ac:graphicFrameMk id="4" creationId="{07AB0080-2014-A8C0-6C2C-255EDEE9D70D}"/>
          </ac:graphicFrameMkLst>
        </pc:graphicFrameChg>
        <pc:cxnChg chg="add mod">
          <ac:chgData name="Panne, Isabelle" userId="68246d2c-cea7-41e5-ae68-061af3e0a041" providerId="ADAL" clId="{7F90142C-2691-4CAD-A9FA-FC7E7537B507}" dt="2026-04-15T20:34:28.221" v="2"/>
          <ac:cxnSpMkLst>
            <pc:docMk/>
            <pc:sldMk cId="1907904869" sldId="256"/>
            <ac:cxnSpMk id="6" creationId="{962FF83C-D095-06DB-C047-8F23F8F1A648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clarunis-my.sharepoint.com/personal/isabelle_panne_clarunis_ch/Documents/CaseReportPaiano/Frontiers/Unterlagen%20f&#252;r%20Review/Laborwerte%20tabellarisch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AST (U/L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Tabelle1!$A$2:$A$29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Tabelle1!$B$2:$B$29</c:f>
              <c:numCache>
                <c:formatCode>General</c:formatCode>
                <c:ptCount val="28"/>
                <c:pt idx="0">
                  <c:v>128</c:v>
                </c:pt>
                <c:pt idx="1">
                  <c:v>201</c:v>
                </c:pt>
                <c:pt idx="2">
                  <c:v>125</c:v>
                </c:pt>
                <c:pt idx="3">
                  <c:v>34</c:v>
                </c:pt>
                <c:pt idx="4">
                  <c:v>31</c:v>
                </c:pt>
                <c:pt idx="5">
                  <c:v>21</c:v>
                </c:pt>
                <c:pt idx="6">
                  <c:v>36</c:v>
                </c:pt>
                <c:pt idx="7">
                  <c:v>40</c:v>
                </c:pt>
                <c:pt idx="8">
                  <c:v>37</c:v>
                </c:pt>
                <c:pt idx="9">
                  <c:v>39</c:v>
                </c:pt>
                <c:pt idx="10">
                  <c:v>22</c:v>
                </c:pt>
                <c:pt idx="11">
                  <c:v>41</c:v>
                </c:pt>
                <c:pt idx="12">
                  <c:v>58</c:v>
                </c:pt>
                <c:pt idx="13">
                  <c:v>38</c:v>
                </c:pt>
                <c:pt idx="14">
                  <c:v>25</c:v>
                </c:pt>
                <c:pt idx="15">
                  <c:v>29</c:v>
                </c:pt>
                <c:pt idx="16">
                  <c:v>32</c:v>
                </c:pt>
                <c:pt idx="17">
                  <c:v>30</c:v>
                </c:pt>
                <c:pt idx="18">
                  <c:v>27</c:v>
                </c:pt>
                <c:pt idx="19">
                  <c:v>28</c:v>
                </c:pt>
                <c:pt idx="20">
                  <c:v>28</c:v>
                </c:pt>
                <c:pt idx="21">
                  <c:v>32</c:v>
                </c:pt>
                <c:pt idx="22">
                  <c:v>30</c:v>
                </c:pt>
                <c:pt idx="23">
                  <c:v>25</c:v>
                </c:pt>
                <c:pt idx="24">
                  <c:v>28</c:v>
                </c:pt>
                <c:pt idx="25">
                  <c:v>30</c:v>
                </c:pt>
                <c:pt idx="26">
                  <c:v>3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491-4D2D-BB11-CAA36BC55B17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ALT (U/L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Tabelle1!$A$2:$A$29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Tabelle1!$C$2:$C$29</c:f>
              <c:numCache>
                <c:formatCode>General</c:formatCode>
                <c:ptCount val="28"/>
                <c:pt idx="0">
                  <c:v>116</c:v>
                </c:pt>
                <c:pt idx="1">
                  <c:v>142</c:v>
                </c:pt>
                <c:pt idx="2">
                  <c:v>83</c:v>
                </c:pt>
                <c:pt idx="3">
                  <c:v>75</c:v>
                </c:pt>
                <c:pt idx="4">
                  <c:v>43</c:v>
                </c:pt>
                <c:pt idx="5">
                  <c:v>24</c:v>
                </c:pt>
                <c:pt idx="6">
                  <c:v>27</c:v>
                </c:pt>
                <c:pt idx="7">
                  <c:v>24</c:v>
                </c:pt>
                <c:pt idx="8">
                  <c:v>33</c:v>
                </c:pt>
                <c:pt idx="9">
                  <c:v>44</c:v>
                </c:pt>
                <c:pt idx="10">
                  <c:v>23</c:v>
                </c:pt>
                <c:pt idx="11">
                  <c:v>42</c:v>
                </c:pt>
                <c:pt idx="12">
                  <c:v>71</c:v>
                </c:pt>
                <c:pt idx="13">
                  <c:v>32</c:v>
                </c:pt>
                <c:pt idx="14">
                  <c:v>44</c:v>
                </c:pt>
                <c:pt idx="15">
                  <c:v>25</c:v>
                </c:pt>
                <c:pt idx="16">
                  <c:v>42</c:v>
                </c:pt>
                <c:pt idx="17">
                  <c:v>32</c:v>
                </c:pt>
                <c:pt idx="18">
                  <c:v>23</c:v>
                </c:pt>
                <c:pt idx="19">
                  <c:v>22</c:v>
                </c:pt>
                <c:pt idx="20">
                  <c:v>21</c:v>
                </c:pt>
                <c:pt idx="21">
                  <c:v>20</c:v>
                </c:pt>
                <c:pt idx="22">
                  <c:v>28</c:v>
                </c:pt>
                <c:pt idx="23">
                  <c:v>28</c:v>
                </c:pt>
                <c:pt idx="24">
                  <c:v>21</c:v>
                </c:pt>
                <c:pt idx="25">
                  <c:v>23</c:v>
                </c:pt>
                <c:pt idx="26">
                  <c:v>26</c:v>
                </c:pt>
                <c:pt idx="27">
                  <c:v>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491-4D2D-BB11-CAA36BC55B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9525" cap="flat" cmpd="sng" algn="ctr">
              <a:solidFill>
                <a:schemeClr val="tx1">
                  <a:lumMod val="35000"/>
                  <a:lumOff val="65000"/>
                </a:schemeClr>
              </a:solidFill>
              <a:round/>
            </a:ln>
            <a:effectLst/>
          </c:spPr>
        </c:dropLines>
        <c:smooth val="0"/>
        <c:axId val="1083288272"/>
        <c:axId val="1077461312"/>
      </c:lineChart>
      <c:catAx>
        <c:axId val="10832882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onth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077461312"/>
        <c:crosses val="autoZero"/>
        <c:auto val="1"/>
        <c:lblAlgn val="ctr"/>
        <c:lblOffset val="100"/>
        <c:noMultiLvlLbl val="0"/>
      </c:catAx>
      <c:valAx>
        <c:axId val="10774613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U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0832882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8909</cdr:x>
      <cdr:y>0.70908</cdr:y>
    </cdr:from>
    <cdr:to>
      <cdr:x>0.28942</cdr:x>
      <cdr:y>0.73709</cdr:y>
    </cdr:to>
    <cdr:cxnSp macro="">
      <cdr:nvCxnSpPr>
        <cdr:cNvPr id="4" name="Gerade Verbindung mit Pfeil 3">
          <a:extLst xmlns:a="http://schemas.openxmlformats.org/drawingml/2006/main">
            <a:ext uri="{FF2B5EF4-FFF2-40B4-BE49-F238E27FC236}">
              <a16:creationId xmlns:a16="http://schemas.microsoft.com/office/drawing/2014/main" id="{B95B5552-7471-B29C-09C0-DB862DCB8224}"/>
            </a:ext>
          </a:extLst>
        </cdr:cNvPr>
        <cdr:cNvCxnSpPr/>
      </cdr:nvCxnSpPr>
      <cdr:spPr>
        <a:xfrm xmlns:a="http://schemas.openxmlformats.org/drawingml/2006/main" flipH="1">
          <a:off x="2931927" y="3752850"/>
          <a:ext cx="3276" cy="148254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9707</cdr:x>
      <cdr:y>0.45461</cdr:y>
    </cdr:from>
    <cdr:to>
      <cdr:x>0.76227</cdr:x>
      <cdr:y>0.51277</cdr:y>
    </cdr:to>
    <cdr:sp macro="" textlink="">
      <cdr:nvSpPr>
        <cdr:cNvPr id="9" name="Textfeld 17">
          <a:extLst xmlns:a="http://schemas.openxmlformats.org/drawingml/2006/main">
            <a:ext uri="{FF2B5EF4-FFF2-40B4-BE49-F238E27FC236}">
              <a16:creationId xmlns:a16="http://schemas.microsoft.com/office/drawing/2014/main" id="{245DBFCD-75B8-8FE6-7A09-EE7A704CE56C}"/>
            </a:ext>
          </a:extLst>
        </cdr:cNvPr>
        <cdr:cNvSpPr txBox="1"/>
      </cdr:nvSpPr>
      <cdr:spPr>
        <a:xfrm xmlns:a="http://schemas.openxmlformats.org/drawingml/2006/main">
          <a:off x="5832699" y="1821444"/>
          <a:ext cx="1613827" cy="23302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de-D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de-CH" sz="1400" b="1" dirty="0" err="1">
              <a:solidFill>
                <a:srgbClr val="7030A0"/>
              </a:solidFill>
            </a:rPr>
            <a:t>Stop</a:t>
          </a:r>
          <a:r>
            <a:rPr lang="de-CH" sz="1400" b="1" dirty="0">
              <a:solidFill>
                <a:srgbClr val="7030A0"/>
              </a:solidFill>
            </a:rPr>
            <a:t> </a:t>
          </a:r>
          <a:r>
            <a:rPr lang="de-CH" sz="1400" b="1" dirty="0" err="1">
              <a:solidFill>
                <a:srgbClr val="7030A0"/>
              </a:solidFill>
            </a:rPr>
            <a:t>Prednisone</a:t>
          </a:r>
          <a:endParaRPr lang="de-CH" sz="1400" b="1" dirty="0">
            <a:solidFill>
              <a:srgbClr val="7030A0"/>
            </a:solidFill>
          </a:endParaRPr>
        </a:p>
      </cdr:txBody>
    </cdr:sp>
  </cdr:relSizeAnchor>
  <cdr:relSizeAnchor xmlns:cdr="http://schemas.openxmlformats.org/drawingml/2006/chartDrawing">
    <cdr:from>
      <cdr:x>0.64628</cdr:x>
      <cdr:y>0.53807</cdr:y>
    </cdr:from>
    <cdr:to>
      <cdr:x>0.64628</cdr:x>
      <cdr:y>0.72059</cdr:y>
    </cdr:to>
    <cdr:cxnSp macro="">
      <cdr:nvCxnSpPr>
        <cdr:cNvPr id="11" name="Gerade Verbindung mit Pfeil 10">
          <a:extLst xmlns:a="http://schemas.openxmlformats.org/drawingml/2006/main">
            <a:ext uri="{FF2B5EF4-FFF2-40B4-BE49-F238E27FC236}">
              <a16:creationId xmlns:a16="http://schemas.microsoft.com/office/drawing/2014/main" id="{AAD940FF-DD44-CD37-9857-3283CFC0F573}"/>
            </a:ext>
          </a:extLst>
        </cdr:cNvPr>
        <cdr:cNvCxnSpPr/>
      </cdr:nvCxnSpPr>
      <cdr:spPr>
        <a:xfrm xmlns:a="http://schemas.openxmlformats.org/drawingml/2006/main">
          <a:off x="6313467" y="2155831"/>
          <a:ext cx="0" cy="731281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</cdr:x>
      <cdr:y>0.03319</cdr:y>
    </cdr:from>
    <cdr:to>
      <cdr:x>0.18224</cdr:x>
      <cdr:y>0.09134</cdr:y>
    </cdr:to>
    <cdr:sp macro="" textlink="">
      <cdr:nvSpPr>
        <cdr:cNvPr id="3" name="Textfeld 17">
          <a:extLst xmlns:a="http://schemas.openxmlformats.org/drawingml/2006/main">
            <a:ext uri="{FF2B5EF4-FFF2-40B4-BE49-F238E27FC236}">
              <a16:creationId xmlns:a16="http://schemas.microsoft.com/office/drawing/2014/main" id="{245DBFCD-75B8-8FE6-7A09-EE7A704CE56C}"/>
            </a:ext>
          </a:extLst>
        </cdr:cNvPr>
        <cdr:cNvSpPr txBox="1"/>
      </cdr:nvSpPr>
      <cdr:spPr>
        <a:xfrm xmlns:a="http://schemas.openxmlformats.org/drawingml/2006/main">
          <a:off x="-735062" y="150916"/>
          <a:ext cx="1710426" cy="26437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de-D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de-CH" sz="1400" b="1" dirty="0" err="1"/>
            <a:t>Antibiotic</a:t>
          </a:r>
          <a:r>
            <a:rPr lang="de-CH" sz="1400" b="1" dirty="0"/>
            <a:t> </a:t>
          </a:r>
          <a:r>
            <a:rPr lang="de-CH" sz="1400" b="1" dirty="0" err="1"/>
            <a:t>treatment</a:t>
          </a:r>
          <a:endParaRPr lang="de-CH" sz="1400" b="1" dirty="0"/>
        </a:p>
      </cdr:txBody>
    </cdr:sp>
  </cdr:relSizeAnchor>
  <cdr:relSizeAnchor xmlns:cdr="http://schemas.openxmlformats.org/drawingml/2006/chartDrawing">
    <cdr:from>
      <cdr:x>0.08264</cdr:x>
      <cdr:y>0.18003</cdr:y>
    </cdr:from>
    <cdr:to>
      <cdr:x>0.08264</cdr:x>
      <cdr:y>0.24126</cdr:y>
    </cdr:to>
    <cdr:cxnSp macro="">
      <cdr:nvCxnSpPr>
        <cdr:cNvPr id="5" name="Gerade Verbindung mit Pfeil 4">
          <a:extLst xmlns:a="http://schemas.openxmlformats.org/drawingml/2006/main">
            <a:ext uri="{FF2B5EF4-FFF2-40B4-BE49-F238E27FC236}">
              <a16:creationId xmlns:a16="http://schemas.microsoft.com/office/drawing/2014/main" id="{4EBADFA4-8123-CAF5-3973-85E5E18DD53B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807297" y="721300"/>
          <a:ext cx="0" cy="245324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D68ECA-609A-428C-AAE3-544783A3FC75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F2BF2-7C68-4BA9-9579-13031BB4C09F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84500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5F2BF2-7C68-4BA9-9579-13031BB4C09F}" type="slidenum">
              <a:rPr lang="de-CH" smtClean="0"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138031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11F2D6B-F263-89F8-B84A-D848D19D73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5DF9DAC4-DB6A-E2B4-F7AE-6EB37AEEB6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6AA28EC-6BDE-7924-ECBF-4E41603E3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B6A7B4B-3021-F4D5-2788-A19D25B3A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44E8FBF-791F-1071-B149-00C84DD87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01363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6E9AF5-C8A3-890F-B016-484FAEE7EE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84967D7-9CA8-9FEA-6BB1-E0B89ADEC9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83AA4B1-27AA-BFC3-EFA4-7F265A507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32B02A0-EB92-E49F-C3E7-406D9817F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194A980-AF78-BB42-A671-AC80AF426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15477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DF00841-ADAF-6842-CCD9-E03361F1E4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2B6F9DB-C5A4-6371-8C7F-ED27F95D66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E202962-89FD-8389-B3B6-1FCDD9BCB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78579E5-A8E9-1276-43CE-E7E98AB98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400BE99-94CB-DA64-09C5-0AC9D4341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79916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338293C-E942-347F-8F10-2F495AD56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2216FF3-CDBD-9220-2389-98622A774E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147E330-5AB9-402A-EF69-100CBBE363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1392655-DF4B-3FC5-40EB-9F3BBD34D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854E013-AEAB-037F-7EF9-20B7B6CE9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6944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BAD876C-3DC5-D758-CA3E-2232E99F1F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3B92610-A3A9-17A1-FD51-FD059569E6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DA3E0E9-3FB0-1053-1EE3-A17DB7DE1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19FEC01-55DE-5A15-4667-99D00D3793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D1A58D6-4278-6185-170B-9398A9B6F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12182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A9A4E0E-FC03-5C9D-9B06-CC5DB42B93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B84B85C-75EA-C556-0BB1-ABB0416C3A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49FB83E-9DD1-F38A-6304-85B4D92FA9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4894578-7C64-773A-FD93-BB57D2B96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8345B20-4A4E-329B-F872-2978E6789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AFE445F-75A1-854B-4CE3-4D4F2EDA5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99268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D916DAA-7257-D148-FEC1-98FC851D10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1D66C07-A090-FDE3-BF46-93F49A46AD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08DD957-25E1-D033-183A-A9AF21283D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79231F0-A8C8-8821-9E44-EA7F1C0EC9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79CC01B-2A9F-4609-860A-0E7C724D33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C2CE2CC-AE5F-F170-71E3-657280430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0D896AB5-A28B-9ABB-306B-8BCDECF0E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1E6F9BB-8794-82F6-8EF3-FE3AF6C86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57761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5F0271-92CD-9238-C2CC-202773CFA2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E8C6AB2-F077-17A3-5FE9-C727E99A4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2EAAA51-2419-0EB2-559F-F65E9E7AF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A039FBE-CE50-5593-8D3D-426EBF7CE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62958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80CC226-B6AC-0558-5471-85981DBB9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A968FE0-8085-BB3C-F1B4-0F0A8A4A0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C48C5C9-0248-7B82-7495-632FDBB32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4760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6ADFB98-ED4F-499F-4C5E-D3E753EDAF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4E2247A-FF89-CB13-B37D-402611B7A7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594387F-D0AF-EDBB-B2E6-62F6997D2E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3C1D2AC-4EEA-A258-AD08-8DB4D3F22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8E411C9-1219-8FCC-B957-3478B0705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F2CCE14-E96E-D5D4-9B8D-1FB8B53C7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72848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E7A65C3-DF6E-5F0A-9F37-6643127C6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07E84EC7-577C-F315-829B-3F3DF81611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EDF2C6A-B374-EAA0-33D9-09F4FAFD2C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CC2A399-22B1-2D04-4D84-247950BA5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A6FF8EF-08E3-1B0E-D97C-D47B8BB12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6AD6069-AAD2-2EF1-70DB-D77063779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68790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01EF2D4-2BA2-31E1-E176-B113A4C18B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71EC028-A332-D871-3B74-8E086968E1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5BB3F88-8187-6A43-9089-998ADA921A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AE131A-8D4F-4C72-9299-7A1E4A2D0168}" type="datetimeFigureOut">
              <a:rPr lang="de-CH" smtClean="0"/>
              <a:t>25.04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CE3A77C-0B5C-C88B-A246-B0FE0ACEE6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5D72F5C-E706-321F-F97C-4EB616077F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8A870A-88BB-49E3-AEF3-567B0DDF1BD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51153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07AB0080-2014-A8C0-6C2C-255EDEE9D7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1532183"/>
              </p:ext>
            </p:extLst>
          </p:nvPr>
        </p:nvGraphicFramePr>
        <p:xfrm>
          <a:off x="785445" y="704606"/>
          <a:ext cx="9768934" cy="4006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8" name="Grafik 7">
            <a:extLst>
              <a:ext uri="{FF2B5EF4-FFF2-40B4-BE49-F238E27FC236}">
                <a16:creationId xmlns:a16="http://schemas.microsoft.com/office/drawing/2014/main" id="{26687E33-857F-23F8-73A0-31CE16E83F3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4207" t="14105" r="9404" b="13406"/>
          <a:stretch>
            <a:fillRect/>
          </a:stretch>
        </p:blipFill>
        <p:spPr>
          <a:xfrm>
            <a:off x="153082" y="4375375"/>
            <a:ext cx="1867497" cy="1659733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EFBD28F9-A844-68BB-0AA0-8FC5EA060B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16004" y="4380077"/>
            <a:ext cx="1933381" cy="1622135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8E69B8B7-4933-0B5F-A99B-54F2F732004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73044" y="4380077"/>
            <a:ext cx="2141760" cy="1622135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2C759F45-CC45-E3B0-FBDF-19ABE8636DB5}"/>
              </a:ext>
            </a:extLst>
          </p:cNvPr>
          <p:cNvSpPr txBox="1"/>
          <p:nvPr/>
        </p:nvSpPr>
        <p:spPr>
          <a:xfrm>
            <a:off x="8142659" y="6130301"/>
            <a:ext cx="3007891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300" b="1" dirty="0">
                <a:latin typeface="+mj-lt"/>
                <a:cs typeface="Times New Roman" panose="02020603050405020304" pitchFamily="18" charset="0"/>
              </a:rPr>
              <a:t>Normal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ophthalmologic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findings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,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c</a:t>
            </a:r>
            <a:r>
              <a:rPr lang="de-CH" sz="1300" b="1" dirty="0" err="1">
                <a:cs typeface="Times New Roman" panose="02020603050405020304" pitchFamily="18" charset="0"/>
              </a:rPr>
              <a:t>omplete</a:t>
            </a:r>
            <a:r>
              <a:rPr lang="de-CH" sz="1300" b="1" dirty="0"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cs typeface="Times New Roman" panose="02020603050405020304" pitchFamily="18" charset="0"/>
              </a:rPr>
              <a:t>clinical</a:t>
            </a:r>
            <a:r>
              <a:rPr lang="de-CH" sz="1300" b="1" dirty="0">
                <a:cs typeface="Times New Roman" panose="02020603050405020304" pitchFamily="18" charset="0"/>
              </a:rPr>
              <a:t>,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radiological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and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aboratory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remission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01/2026</a:t>
            </a:r>
          </a:p>
        </p:txBody>
      </p:sp>
      <p:sp>
        <p:nvSpPr>
          <p:cNvPr id="15" name="Textfeld 10">
            <a:extLst>
              <a:ext uri="{FF2B5EF4-FFF2-40B4-BE49-F238E27FC236}">
                <a16:creationId xmlns:a16="http://schemas.microsoft.com/office/drawing/2014/main" id="{B8627E23-E090-2D48-4C61-2A4994D37522}"/>
              </a:ext>
            </a:extLst>
          </p:cNvPr>
          <p:cNvSpPr txBox="1"/>
          <p:nvPr/>
        </p:nvSpPr>
        <p:spPr>
          <a:xfrm>
            <a:off x="43125" y="6035111"/>
            <a:ext cx="2522497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CH" sz="1300" b="1" dirty="0">
                <a:latin typeface="+mj-lt"/>
                <a:cs typeface="Times New Roman" panose="02020603050405020304" pitchFamily="18" charset="0"/>
              </a:rPr>
              <a:t>Fatigue/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weight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oss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,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disseminated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iver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esions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, high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iver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parameters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and CRP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evels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12/2023</a:t>
            </a:r>
          </a:p>
        </p:txBody>
      </p: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0D229F4F-7A98-7FD6-1BA1-B2C53F57C52A}"/>
              </a:ext>
            </a:extLst>
          </p:cNvPr>
          <p:cNvCxnSpPr>
            <a:cxnSpLocks/>
          </p:cNvCxnSpPr>
          <p:nvPr/>
        </p:nvCxnSpPr>
        <p:spPr>
          <a:xfrm flipV="1">
            <a:off x="1090246" y="3591718"/>
            <a:ext cx="412551" cy="44657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feld 17">
            <a:extLst>
              <a:ext uri="{FF2B5EF4-FFF2-40B4-BE49-F238E27FC236}">
                <a16:creationId xmlns:a16="http://schemas.microsoft.com/office/drawing/2014/main" id="{245DBFCD-75B8-8FE6-7A09-EE7A704CE56C}"/>
              </a:ext>
            </a:extLst>
          </p:cNvPr>
          <p:cNvSpPr txBox="1"/>
          <p:nvPr/>
        </p:nvSpPr>
        <p:spPr>
          <a:xfrm>
            <a:off x="2404605" y="396830"/>
            <a:ext cx="1675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>
                <a:solidFill>
                  <a:schemeClr val="accent5">
                    <a:lumMod val="75000"/>
                  </a:schemeClr>
                </a:solidFill>
              </a:rPr>
              <a:t>Start </a:t>
            </a:r>
            <a:r>
              <a:rPr lang="de-CH" sz="1400" b="1" dirty="0" err="1">
                <a:solidFill>
                  <a:schemeClr val="accent5">
                    <a:lumMod val="75000"/>
                  </a:schemeClr>
                </a:solidFill>
              </a:rPr>
              <a:t>Prednisone</a:t>
            </a:r>
            <a:endParaRPr lang="de-CH" sz="14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cxnSp>
        <p:nvCxnSpPr>
          <p:cNvPr id="20" name="Gerade Verbindung mit Pfeil 19">
            <a:extLst>
              <a:ext uri="{FF2B5EF4-FFF2-40B4-BE49-F238E27FC236}">
                <a16:creationId xmlns:a16="http://schemas.microsoft.com/office/drawing/2014/main" id="{4EBADFA4-8123-CAF5-3973-85E5E18DD53B}"/>
              </a:ext>
            </a:extLst>
          </p:cNvPr>
          <p:cNvCxnSpPr>
            <a:cxnSpLocks/>
          </p:cNvCxnSpPr>
          <p:nvPr/>
        </p:nvCxnSpPr>
        <p:spPr>
          <a:xfrm flipH="1">
            <a:off x="2011680" y="705236"/>
            <a:ext cx="980801" cy="75404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feld 24">
            <a:extLst>
              <a:ext uri="{FF2B5EF4-FFF2-40B4-BE49-F238E27FC236}">
                <a16:creationId xmlns:a16="http://schemas.microsoft.com/office/drawing/2014/main" id="{FEB0B325-0613-2994-0DE8-BFF462A8CABA}"/>
              </a:ext>
            </a:extLst>
          </p:cNvPr>
          <p:cNvSpPr txBox="1"/>
          <p:nvPr/>
        </p:nvSpPr>
        <p:spPr>
          <a:xfrm>
            <a:off x="5251264" y="4911492"/>
            <a:ext cx="1675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/>
              <a:t>Relapse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0622E935-0D25-3E4D-8A46-AC8F2ED22147}"/>
              </a:ext>
            </a:extLst>
          </p:cNvPr>
          <p:cNvSpPr txBox="1"/>
          <p:nvPr/>
        </p:nvSpPr>
        <p:spPr>
          <a:xfrm>
            <a:off x="4439951" y="881039"/>
            <a:ext cx="16754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>
                <a:solidFill>
                  <a:schemeClr val="accent5">
                    <a:lumMod val="75000"/>
                  </a:schemeClr>
                </a:solidFill>
              </a:rPr>
              <a:t>Re-start </a:t>
            </a:r>
            <a:r>
              <a:rPr lang="de-CH" sz="1400" b="1" dirty="0" err="1">
                <a:solidFill>
                  <a:schemeClr val="accent5">
                    <a:lumMod val="75000"/>
                  </a:schemeClr>
                </a:solidFill>
              </a:rPr>
              <a:t>Prednisone</a:t>
            </a:r>
            <a:endParaRPr lang="de-CH" sz="14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969D66A4-744C-ACD7-7BAB-4A866BA861B3}"/>
              </a:ext>
            </a:extLst>
          </p:cNvPr>
          <p:cNvCxnSpPr>
            <a:cxnSpLocks/>
          </p:cNvCxnSpPr>
          <p:nvPr/>
        </p:nvCxnSpPr>
        <p:spPr>
          <a:xfrm>
            <a:off x="5253988" y="1459278"/>
            <a:ext cx="4293" cy="168170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feld 35">
            <a:extLst>
              <a:ext uri="{FF2B5EF4-FFF2-40B4-BE49-F238E27FC236}">
                <a16:creationId xmlns:a16="http://schemas.microsoft.com/office/drawing/2014/main" id="{20C9EF9D-A38E-ABDF-1773-B004DC959EC8}"/>
              </a:ext>
            </a:extLst>
          </p:cNvPr>
          <p:cNvSpPr txBox="1"/>
          <p:nvPr/>
        </p:nvSpPr>
        <p:spPr>
          <a:xfrm>
            <a:off x="5521879" y="1665835"/>
            <a:ext cx="1675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>
                <a:solidFill>
                  <a:srgbClr val="FF0000"/>
                </a:solidFill>
              </a:rPr>
              <a:t>Start Infliximab</a:t>
            </a:r>
          </a:p>
        </p:txBody>
      </p: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E7941BA5-860D-2D02-09CA-0803DE9B0AF5}"/>
              </a:ext>
            </a:extLst>
          </p:cNvPr>
          <p:cNvCxnSpPr>
            <a:cxnSpLocks/>
          </p:cNvCxnSpPr>
          <p:nvPr/>
        </p:nvCxnSpPr>
        <p:spPr>
          <a:xfrm>
            <a:off x="6359598" y="2032227"/>
            <a:ext cx="0" cy="139677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feld 22">
            <a:extLst>
              <a:ext uri="{FF2B5EF4-FFF2-40B4-BE49-F238E27FC236}">
                <a16:creationId xmlns:a16="http://schemas.microsoft.com/office/drawing/2014/main" id="{0E57D767-89E1-9C81-9D02-16D5E3DA9C14}"/>
              </a:ext>
            </a:extLst>
          </p:cNvPr>
          <p:cNvSpPr txBox="1"/>
          <p:nvPr/>
        </p:nvSpPr>
        <p:spPr>
          <a:xfrm>
            <a:off x="26922" y="3350789"/>
            <a:ext cx="138571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/>
              <a:t>Liver and </a:t>
            </a:r>
            <a:r>
              <a:rPr lang="de-CH" sz="1400" b="1" dirty="0" err="1"/>
              <a:t>conjunctiva</a:t>
            </a:r>
            <a:r>
              <a:rPr lang="de-CH" sz="1400" b="1" dirty="0"/>
              <a:t> </a:t>
            </a:r>
            <a:r>
              <a:rPr lang="de-CH" sz="1400" b="1" dirty="0" err="1"/>
              <a:t>biopsy</a:t>
            </a:r>
            <a:endParaRPr lang="de-CH" sz="1400" b="1" dirty="0"/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670042BD-3545-4D98-79EE-289EC6F40473}"/>
              </a:ext>
            </a:extLst>
          </p:cNvPr>
          <p:cNvSpPr txBox="1"/>
          <p:nvPr/>
        </p:nvSpPr>
        <p:spPr>
          <a:xfrm>
            <a:off x="5339624" y="6035108"/>
            <a:ext cx="18576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b="1" dirty="0" err="1"/>
              <a:t>Elevated</a:t>
            </a:r>
            <a:r>
              <a:rPr lang="de-CH" sz="1400" b="1" dirty="0"/>
              <a:t> </a:t>
            </a:r>
            <a:r>
              <a:rPr lang="de-CH" sz="1400" b="1" dirty="0" err="1"/>
              <a:t>liver</a:t>
            </a:r>
            <a:r>
              <a:rPr lang="de-CH" sz="1400" b="1" dirty="0"/>
              <a:t> </a:t>
            </a:r>
            <a:r>
              <a:rPr lang="de-CH" sz="1400" b="1" dirty="0" err="1"/>
              <a:t>enzymes</a:t>
            </a:r>
            <a:r>
              <a:rPr lang="de-CH" sz="1400" b="1" dirty="0"/>
              <a:t>, Uveitis anterior</a:t>
            </a:r>
          </a:p>
        </p:txBody>
      </p:sp>
      <p:cxnSp>
        <p:nvCxnSpPr>
          <p:cNvPr id="6" name="Gerade Verbindung mit Pfeil 5">
            <a:extLst>
              <a:ext uri="{FF2B5EF4-FFF2-40B4-BE49-F238E27FC236}">
                <a16:creationId xmlns:a16="http://schemas.microsoft.com/office/drawing/2014/main" id="{962FF83C-D095-06DB-C047-8F23F8F1A648}"/>
              </a:ext>
            </a:extLst>
          </p:cNvPr>
          <p:cNvCxnSpPr>
            <a:cxnSpLocks/>
          </p:cNvCxnSpPr>
          <p:nvPr/>
        </p:nvCxnSpPr>
        <p:spPr>
          <a:xfrm flipH="1" flipV="1">
            <a:off x="5099538" y="4412975"/>
            <a:ext cx="844062" cy="162213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feld 10">
            <a:extLst>
              <a:ext uri="{FF2B5EF4-FFF2-40B4-BE49-F238E27FC236}">
                <a16:creationId xmlns:a16="http://schemas.microsoft.com/office/drawing/2014/main" id="{5CD3D1AF-C258-3EE0-ED06-64179425358F}"/>
              </a:ext>
            </a:extLst>
          </p:cNvPr>
          <p:cNvSpPr txBox="1"/>
          <p:nvPr/>
        </p:nvSpPr>
        <p:spPr>
          <a:xfrm>
            <a:off x="2454602" y="6035108"/>
            <a:ext cx="2803679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Resolving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iver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esions,normal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ophthalmologic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finding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,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normalization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of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liver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300" b="1" dirty="0" err="1">
                <a:latin typeface="+mj-lt"/>
                <a:cs typeface="Times New Roman" panose="02020603050405020304" pitchFamily="18" charset="0"/>
              </a:rPr>
              <a:t>enzymes</a:t>
            </a:r>
            <a:r>
              <a:rPr lang="de-CH" sz="1300" b="1" dirty="0">
                <a:latin typeface="+mj-lt"/>
                <a:cs typeface="Times New Roman" panose="02020603050405020304" pitchFamily="18" charset="0"/>
              </a:rPr>
              <a:t> 06/2024</a:t>
            </a:r>
          </a:p>
        </p:txBody>
      </p:sp>
    </p:spTree>
    <p:extLst>
      <p:ext uri="{BB962C8B-B14F-4D97-AF65-F5344CB8AC3E}">
        <p14:creationId xmlns:p14="http://schemas.microsoft.com/office/powerpoint/2010/main" val="1907904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Breitbild</PresentationFormat>
  <Paragraphs>14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nne, Isabelle</dc:creator>
  <cp:lastModifiedBy>Panne Isabelle</cp:lastModifiedBy>
  <cp:revision>4</cp:revision>
  <dcterms:created xsi:type="dcterms:W3CDTF">2026-04-12T13:39:19Z</dcterms:created>
  <dcterms:modified xsi:type="dcterms:W3CDTF">2026-04-25T11:38:14Z</dcterms:modified>
</cp:coreProperties>
</file>